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1" r:id="rId2"/>
    <p:sldId id="262" r:id="rId3"/>
    <p:sldId id="264" r:id="rId4"/>
  </p:sldIdLst>
  <p:sldSz cx="9144000" cy="6858000" type="screen4x3"/>
  <p:notesSz cx="6950075" cy="9236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1522" y="-15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4"/>
    </mc:Choice>
    <mc:Fallback>
      <c:style val="4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mir-10b overexpression 231 cell'!$C$12</c:f>
              <c:strCache>
                <c:ptCount val="1"/>
                <c:pt idx="0">
                  <c:v>miR-10b </c:v>
                </c:pt>
              </c:strCache>
            </c:strRef>
          </c:tx>
          <c:spPr>
            <a:solidFill>
              <a:sysClr val="windowText" lastClr="000000">
                <a:lumMod val="65000"/>
                <a:lumOff val="35000"/>
              </a:sys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'mir-10b overexpression 231 cell'!$E$12,'mir-10b overexpression 231 cell'!$G$12)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5.923242361630697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('mir-10b overexpression 231 cell'!$D$11,'mir-10b overexpression 231 cell'!$F$11)</c:f>
              <c:strCache>
                <c:ptCount val="2"/>
                <c:pt idx="0">
                  <c:v>231 vector media</c:v>
                </c:pt>
                <c:pt idx="1">
                  <c:v>231 miR-10b stable media</c:v>
                </c:pt>
              </c:strCache>
            </c:strRef>
          </c:cat>
          <c:val>
            <c:numRef>
              <c:f>('mir-10b overexpression 231 cell'!$D$12,'mir-10b overexpression 231 cell'!$F$12)</c:f>
              <c:numCache>
                <c:formatCode>General</c:formatCode>
                <c:ptCount val="2"/>
                <c:pt idx="0">
                  <c:v>1</c:v>
                </c:pt>
                <c:pt idx="1">
                  <c:v>41.7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08347648"/>
        <c:axId val="308352896"/>
      </c:barChart>
      <c:catAx>
        <c:axId val="308347648"/>
        <c:scaling>
          <c:orientation val="minMax"/>
        </c:scaling>
        <c:delete val="0"/>
        <c:axPos val="b"/>
        <c:majorTickMark val="none"/>
        <c:minorTickMark val="none"/>
        <c:tickLblPos val="nextTo"/>
        <c:crossAx val="308352896"/>
        <c:crosses val="autoZero"/>
        <c:auto val="1"/>
        <c:lblAlgn val="ctr"/>
        <c:lblOffset val="100"/>
        <c:noMultiLvlLbl val="0"/>
      </c:catAx>
      <c:valAx>
        <c:axId val="308352896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sz="1200" dirty="0" smtClean="0"/>
                  <a:t>miR-10b (fold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30834764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8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11699" cy="461804"/>
          </a:xfrm>
          <a:prstGeom prst="rect">
            <a:avLst/>
          </a:prstGeom>
        </p:spPr>
        <p:txBody>
          <a:bodyPr vert="horz" lIns="92492" tIns="46246" rIns="92492" bIns="46246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36768" y="0"/>
            <a:ext cx="3011699" cy="461804"/>
          </a:xfrm>
          <a:prstGeom prst="rect">
            <a:avLst/>
          </a:prstGeom>
        </p:spPr>
        <p:txBody>
          <a:bodyPr vert="horz" lIns="92492" tIns="46246" rIns="92492" bIns="46246" rtlCol="0"/>
          <a:lstStyle>
            <a:lvl1pPr algn="r">
              <a:defRPr sz="1200"/>
            </a:lvl1pPr>
          </a:lstStyle>
          <a:p>
            <a:fld id="{E3884AA6-156C-43BC-BBF5-678CCD633B3D}" type="datetimeFigureOut">
              <a:rPr lang="en-US" smtClean="0"/>
              <a:t>5/30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65225" y="692150"/>
            <a:ext cx="4619625" cy="34639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92" tIns="46246" rIns="92492" bIns="46246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5008" y="4387136"/>
            <a:ext cx="5560060" cy="4156234"/>
          </a:xfrm>
          <a:prstGeom prst="rect">
            <a:avLst/>
          </a:prstGeom>
        </p:spPr>
        <p:txBody>
          <a:bodyPr vert="horz" lIns="92492" tIns="46246" rIns="92492" bIns="46246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772668"/>
            <a:ext cx="3011699" cy="461804"/>
          </a:xfrm>
          <a:prstGeom prst="rect">
            <a:avLst/>
          </a:prstGeom>
        </p:spPr>
        <p:txBody>
          <a:bodyPr vert="horz" lIns="92492" tIns="46246" rIns="92492" bIns="46246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36768" y="8772668"/>
            <a:ext cx="3011699" cy="461804"/>
          </a:xfrm>
          <a:prstGeom prst="rect">
            <a:avLst/>
          </a:prstGeom>
        </p:spPr>
        <p:txBody>
          <a:bodyPr vert="horz" lIns="92492" tIns="46246" rIns="92492" bIns="46246" rtlCol="0" anchor="b"/>
          <a:lstStyle>
            <a:lvl1pPr algn="r">
              <a:defRPr sz="1200"/>
            </a:lvl1pPr>
          </a:lstStyle>
          <a:p>
            <a:fld id="{D005D7CF-2E5B-46B6-BD27-39BF3804B4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30297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3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3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3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3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3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3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30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30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30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3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3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5/3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Box 2"/>
          <p:cNvSpPr txBox="1">
            <a:spLocks noChangeArrowheads="1"/>
          </p:cNvSpPr>
          <p:nvPr/>
        </p:nvSpPr>
        <p:spPr bwMode="auto">
          <a:xfrm>
            <a:off x="2590800" y="4343400"/>
            <a:ext cx="2933700" cy="581025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marL="0" marR="0" algn="just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US" sz="1000" b="1" dirty="0">
                <a:effectLst/>
                <a:latin typeface="Times New Roman"/>
                <a:ea typeface="Calibri"/>
                <a:cs typeface="Times New Roman"/>
              </a:rPr>
              <a:t>Fig S1.</a:t>
            </a:r>
            <a:r>
              <a:rPr lang="en-US" sz="1000" b="1" dirty="0">
                <a:solidFill>
                  <a:srgbClr val="000000"/>
                </a:solidFill>
                <a:effectLst/>
                <a:latin typeface="Calibri"/>
                <a:ea typeface="Times New Roman"/>
                <a:cs typeface="Times New Roman"/>
              </a:rPr>
              <a:t> </a:t>
            </a:r>
            <a:r>
              <a:rPr lang="en-US" sz="1000" dirty="0">
                <a:solidFill>
                  <a:srgbClr val="292526"/>
                </a:solidFill>
                <a:effectLst/>
                <a:latin typeface="Times New Roman"/>
                <a:ea typeface="Calibri"/>
                <a:cs typeface="Times New Roman"/>
              </a:rPr>
              <a:t>miR-10b overexpression in </a:t>
            </a:r>
            <a:r>
              <a:rPr lang="en-US" sz="1000" dirty="0">
                <a:effectLst/>
                <a:latin typeface="Times New Roman"/>
                <a:ea typeface="Calibri"/>
                <a:cs typeface="Times New Roman"/>
              </a:rPr>
              <a:t>exosomes derived from MDA-MB-231 cells stably expressing miR-10b as compared to vector control exosomes.</a:t>
            </a:r>
            <a:endParaRPr lang="en-US" sz="11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685800" y="609600"/>
            <a:ext cx="2286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formation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7696200" y="838200"/>
            <a:ext cx="83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. </a:t>
            </a:r>
            <a:r>
              <a:rPr lang="en-US" dirty="0" smtClean="0"/>
              <a:t>S1</a:t>
            </a:r>
            <a:endParaRPr lang="en-US" dirty="0"/>
          </a:p>
        </p:txBody>
      </p:sp>
      <p:grpSp>
        <p:nvGrpSpPr>
          <p:cNvPr id="10" name="Group 9"/>
          <p:cNvGrpSpPr/>
          <p:nvPr/>
        </p:nvGrpSpPr>
        <p:grpSpPr>
          <a:xfrm>
            <a:off x="2540128" y="2068512"/>
            <a:ext cx="2869565" cy="2133600"/>
            <a:chOff x="5727235" y="788537"/>
            <a:chExt cx="3200400" cy="2513112"/>
          </a:xfrm>
        </p:grpSpPr>
        <p:graphicFrame>
          <p:nvGraphicFramePr>
            <p:cNvPr id="8" name="Chart 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662558385"/>
                </p:ext>
              </p:extLst>
            </p:nvPr>
          </p:nvGraphicFramePr>
          <p:xfrm>
            <a:off x="5727235" y="788537"/>
            <a:ext cx="3200400" cy="251311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9" name="TextBox 4"/>
            <p:cNvSpPr txBox="1">
              <a:spLocks noChangeArrowheads="1"/>
            </p:cNvSpPr>
            <p:nvPr/>
          </p:nvSpPr>
          <p:spPr bwMode="auto">
            <a:xfrm>
              <a:off x="8038123" y="1094554"/>
              <a:ext cx="180028" cy="2725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/>
                  <a:ea typeface="Times New Roman"/>
                  <a:sym typeface="Symbol"/>
                </a:rPr>
                <a:t></a:t>
              </a:r>
              <a:endParaRPr kumimoji="0" lang="en-US" sz="1200" b="0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/>
                <a:ea typeface="Times New Roman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4929550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99586180"/>
              </p:ext>
            </p:extLst>
          </p:nvPr>
        </p:nvGraphicFramePr>
        <p:xfrm>
          <a:off x="304801" y="471971"/>
          <a:ext cx="2148468" cy="6303065"/>
        </p:xfrm>
        <a:graphic>
          <a:graphicData uri="http://schemas.openxmlformats.org/drawingml/2006/table">
            <a:tbl>
              <a:tblPr/>
              <a:tblGrid>
                <a:gridCol w="935216"/>
                <a:gridCol w="606626"/>
                <a:gridCol w="606626"/>
              </a:tblGrid>
              <a:tr h="233657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iRNA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old chang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EM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let-7a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9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37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7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7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5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9a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4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5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3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96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let-7b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9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4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7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5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6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8a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3a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29b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6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34a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3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let-7c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4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9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7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6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8b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3b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6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5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9c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7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34b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9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let-7d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9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0a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5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7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9a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24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30a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34c-5p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let-7e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4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0b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.2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19b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7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5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5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4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30b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92a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5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6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let-7f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7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5a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6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20a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5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5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26a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7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30c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92b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9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5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let-7g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5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4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5b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4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4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0b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5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6b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30e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85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96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let-7i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56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7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16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6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7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87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7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27b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4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3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89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9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4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5922858"/>
              </p:ext>
            </p:extLst>
          </p:nvPr>
        </p:nvGraphicFramePr>
        <p:xfrm>
          <a:off x="2971800" y="446338"/>
          <a:ext cx="2204026" cy="6290840"/>
        </p:xfrm>
        <a:graphic>
          <a:graphicData uri="http://schemas.openxmlformats.org/drawingml/2006/table">
            <a:tbl>
              <a:tblPr/>
              <a:tblGrid>
                <a:gridCol w="952036"/>
                <a:gridCol w="625995"/>
                <a:gridCol w="625995"/>
              </a:tblGrid>
              <a:tr h="175902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iRN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old chang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EM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99a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09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5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100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41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75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01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4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9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03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6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6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06a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8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0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106b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6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3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07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2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0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122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0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1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24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5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8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919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25a-5p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3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0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125b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56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3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26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04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0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26*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95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1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127-5p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2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2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28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2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9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29-5p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8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8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30a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3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1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33a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2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1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33b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5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6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34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55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6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35a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8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5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135b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4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4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36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1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5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37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45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0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38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26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7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40-5p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35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8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141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42-5p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43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7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42-3p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04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1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143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4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8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44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04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8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45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1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8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146a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4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2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5119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146b-5p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70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2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148a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4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8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48b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2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7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49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0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6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50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8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3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51-5p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3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3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53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5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9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54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7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1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155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3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1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81a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9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7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181b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49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8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81c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45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0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181d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61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0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182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7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5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7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183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1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1</a:t>
                      </a:r>
                    </a:p>
                  </a:txBody>
                  <a:tcPr marL="4398" marR="4398" marT="439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659469"/>
              </p:ext>
            </p:extLst>
          </p:nvPr>
        </p:nvGraphicFramePr>
        <p:xfrm>
          <a:off x="5638800" y="413662"/>
          <a:ext cx="2323213" cy="6298220"/>
        </p:xfrm>
        <a:graphic>
          <a:graphicData uri="http://schemas.openxmlformats.org/drawingml/2006/table">
            <a:tbl>
              <a:tblPr/>
              <a:tblGrid>
                <a:gridCol w="1149379"/>
                <a:gridCol w="586917"/>
                <a:gridCol w="586917"/>
              </a:tblGrid>
              <a:tr h="2330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iRN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old chang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EM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84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5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2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85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9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2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86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3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2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88-5p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5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8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90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3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7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91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7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7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92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85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1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93a-5p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3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4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93b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8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2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194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91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7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95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6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4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196a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4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96b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3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3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199a-5p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7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2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199a-3p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2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4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99b-5p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0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2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00a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96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6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00b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5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2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00c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2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02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5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0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03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04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73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2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05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06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6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3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10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8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1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12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84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2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14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8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6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15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7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9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16a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3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9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218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.68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4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219-5p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2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3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20a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85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5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21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97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60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22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76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4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23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7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6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24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70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6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328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0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2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96-5p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3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3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301a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89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5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335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10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1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342-5p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5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1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363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35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1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372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0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9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373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5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1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375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5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5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376a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378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1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7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65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380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1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5</a:t>
                      </a:r>
                    </a:p>
                  </a:txBody>
                  <a:tcPr marL="4437" marR="4437" marT="4437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5" name="Rectangle 4"/>
          <p:cNvSpPr/>
          <p:nvPr/>
        </p:nvSpPr>
        <p:spPr>
          <a:xfrm>
            <a:off x="228600" y="71249"/>
            <a:ext cx="800100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Endogenous level of miRNA expression in MDA-MB-231 cells as compared to HMLE cells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599403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228600" y="71249"/>
            <a:ext cx="800100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.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cretory miRNA expression in MDA-MB-231 supernatant as compared to HMLE supernatant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80929723"/>
              </p:ext>
            </p:extLst>
          </p:nvPr>
        </p:nvGraphicFramePr>
        <p:xfrm>
          <a:off x="228600" y="413662"/>
          <a:ext cx="2377772" cy="6316297"/>
        </p:xfrm>
        <a:graphic>
          <a:graphicData uri="http://schemas.openxmlformats.org/drawingml/2006/table">
            <a:tbl>
              <a:tblPr/>
              <a:tblGrid>
                <a:gridCol w="1042882"/>
                <a:gridCol w="667445"/>
                <a:gridCol w="667445"/>
              </a:tblGrid>
              <a:tr h="246889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iRNA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old chang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EM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let-7a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9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7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6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5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6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9a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5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3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0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8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let-7b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7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8a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3a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4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4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29b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34a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25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94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let-7c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4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9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9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9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8b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7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3b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9c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5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6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34b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9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let-7d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0a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75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9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9a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7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24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4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9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30a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6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34c-5p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7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let-7e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1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9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0b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0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19b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5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9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6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30b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5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9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92a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7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let-7f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2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5a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9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20a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5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26a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9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30c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96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45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92b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89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let-7g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6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5b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6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0b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6b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8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30e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9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96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9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let-7i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4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4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16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4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6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27b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3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5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344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9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9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03810788"/>
              </p:ext>
            </p:extLst>
          </p:nvPr>
        </p:nvGraphicFramePr>
        <p:xfrm>
          <a:off x="2743200" y="401792"/>
          <a:ext cx="2579191" cy="6313249"/>
        </p:xfrm>
        <a:graphic>
          <a:graphicData uri="http://schemas.openxmlformats.org/drawingml/2006/table">
            <a:tbl>
              <a:tblPr/>
              <a:tblGrid>
                <a:gridCol w="1263907"/>
                <a:gridCol w="657642"/>
                <a:gridCol w="657642"/>
              </a:tblGrid>
              <a:tr h="243841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iRNA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old chang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EM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99a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8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5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10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95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0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0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6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06a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106b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9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07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12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24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2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25a-5p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125b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6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5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26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26*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127-5p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2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29-5p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4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30a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2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07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33a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33b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34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66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66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35a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5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135b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36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37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9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3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29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40-5p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6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14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42-5p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42-3p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14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9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7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44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45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146a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146b-5p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148a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48b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7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7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49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5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51-5p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5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7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54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155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81a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9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4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181b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81c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7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181d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6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18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92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18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89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89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97168498"/>
              </p:ext>
            </p:extLst>
          </p:nvPr>
        </p:nvGraphicFramePr>
        <p:xfrm>
          <a:off x="5410200" y="379026"/>
          <a:ext cx="2713174" cy="6310201"/>
        </p:xfrm>
        <a:graphic>
          <a:graphicData uri="http://schemas.openxmlformats.org/drawingml/2006/table">
            <a:tbl>
              <a:tblPr/>
              <a:tblGrid>
                <a:gridCol w="1329564"/>
                <a:gridCol w="691805"/>
                <a:gridCol w="691805"/>
              </a:tblGrid>
              <a:tr h="240793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old chang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EM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84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7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85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9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86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5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88-5p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9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7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9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4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9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93a-5p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93b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194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95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9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4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196a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9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96b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7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5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199a-5p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7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199a-3p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7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199b-5p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00a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00b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6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00c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7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0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5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5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0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9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04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9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05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27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06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34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4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1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7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5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1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9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14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4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7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15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9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16a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7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21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9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219-5p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20a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9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2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9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2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4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2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24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6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4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32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99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9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296-5p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7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301a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9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335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342-5p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36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7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372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4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5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373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7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375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6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6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sa-miR-376a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9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378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1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039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sa-miR-380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29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9</a:t>
                      </a:r>
                    </a:p>
                  </a:txBody>
                  <a:tcPr marL="4526" marR="4526" marT="4526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242433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73</TotalTime>
  <Words>948</Words>
  <Application>Microsoft Office PowerPoint</Application>
  <PresentationFormat>On-screen Show (4:3)</PresentationFormat>
  <Paragraphs>888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mesh Singh</dc:creator>
  <cp:lastModifiedBy>Yin-yuan Mo</cp:lastModifiedBy>
  <cp:revision>81</cp:revision>
  <cp:lastPrinted>2014-05-29T22:21:14Z</cp:lastPrinted>
  <dcterms:created xsi:type="dcterms:W3CDTF">2006-08-16T00:00:00Z</dcterms:created>
  <dcterms:modified xsi:type="dcterms:W3CDTF">2014-05-30T20:27:21Z</dcterms:modified>
</cp:coreProperties>
</file>